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84913" cy="7239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543F7-EE80-4481-82F7-40E8267C97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5343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240" y="4359240"/>
            <a:ext cx="5343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56641-A08B-48FA-9760-7F32FB6AC6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0940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240" y="435924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09400" y="435924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47D5A-205B-4285-9527-EB1CCCF98C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78080" y="209052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84920" y="209052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240" y="435924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78080" y="435924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84920" y="4359240"/>
            <a:ext cx="172044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C84F9-C501-4B1F-9BD9-8DC3BA9C09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240" y="2090520"/>
            <a:ext cx="534348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A7446-FEAA-4EB5-96E8-DC363F6BE3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5343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0EE84-0E20-4886-9EE5-98462BAE2A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2607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09400" y="2090520"/>
            <a:ext cx="2607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79D8C-4689-4B40-8020-7CAA5CDE75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503AD-0A18-48B4-ACF1-F2FB1DD411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240" y="642600"/>
            <a:ext cx="5343480" cy="5593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395CD-73DD-4E19-9728-77C12D169A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09400" y="2090520"/>
            <a:ext cx="2607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240" y="435924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E4D62-8999-493B-BD5E-4BAC1826A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2607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0940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09400" y="435924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42988-A011-4B11-AF19-40ADCAA38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24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09400" y="2090520"/>
            <a:ext cx="2607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240" y="4359240"/>
            <a:ext cx="534348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177EEA-C279-4969-BBEC-45B7FE2C87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240" y="642600"/>
            <a:ext cx="534348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240" y="2090520"/>
            <a:ext cx="534348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0000"/>
          </a:bodyPr>
          <a:p>
            <a:pPr marL="308520" indent="-30852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68520" indent="-2570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028520" indent="-20556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440000" indent="-2055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851480" indent="-20556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851480" indent="-20556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851480" indent="-20556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6595560"/>
            <a:ext cx="130968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47760" y="6595560"/>
            <a:ext cx="199080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05400" y="6595560"/>
            <a:ext cx="130968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4C95DC-F5CC-48CD-BAEC-801922C84FC7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Asty&amp;Fly%20+%20Astx-ref" descr=""/>
          <p:cNvPicPr/>
          <p:nvPr/>
        </p:nvPicPr>
        <p:blipFill>
          <a:blip r:embed="rId1"/>
          <a:stretch/>
        </p:blipFill>
        <p:spPr>
          <a:xfrm>
            <a:off x="495360" y="133200"/>
            <a:ext cx="5505480" cy="64008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43040" y="582480"/>
            <a:ext cx="108000" cy="108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844560" y="503280"/>
            <a:ext cx="150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743040" y="833400"/>
            <a:ext cx="108000" cy="108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844560" y="754200"/>
            <a:ext cx="267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arranged 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743040" y="1085760"/>
            <a:ext cx="108000" cy="108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743040" y="1336680"/>
            <a:ext cx="108000" cy="108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743040" y="1589040"/>
            <a:ext cx="108000" cy="108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844560" y="1003320"/>
            <a:ext cx="267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sty1+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844560" y="1254240"/>
            <a:ext cx="267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844560" y="1503360"/>
            <a:ext cx="267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Unclassifi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273640" y="3319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911760" y="6620040"/>
            <a:ext cx="53172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192400" y="6748560"/>
            <a:ext cx="225108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92200" y="6878520"/>
            <a:ext cx="385128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557520" y="654840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4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847880" y="667692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79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28600" y="680544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.04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273640" y="6602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5273640" y="19796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273640" y="9907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273640" y="21985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273640" y="44136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273640" y="15397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273640" y="7700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273640" y="13190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5273640" y="23083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5273640" y="16495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5273640" y="143028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273640" y="187020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273640" y="55080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5273640" y="208908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5273640" y="120960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5273640" y="110016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5273640" y="88092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5273640" y="175896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5273640" y="307800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5273640" y="351792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5273640" y="373680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5273640" y="450684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5273640" y="384804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5273640" y="274788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5273640" y="285912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5273640" y="505620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5273640" y="318780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5273640" y="252900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5273640" y="461628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5273640" y="472608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5273640" y="483696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5272200" y="539424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5780160" y="494676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5273640" y="5168880"/>
            <a:ext cx="54000" cy="5400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5273640" y="24192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5273640" y="263844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5273640" y="296856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273640" y="329724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5273640" y="34084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5273640" y="362736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5273640" y="39574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5273640" y="40672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5273640" y="417672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5273640" y="428616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5273640" y="43974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272200" y="528156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651640" y="57182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130720" y="582768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129280" y="604980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5129280" y="593892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130720" y="5608800"/>
            <a:ext cx="54000" cy="5364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5130720" y="627228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5130720" y="6161040"/>
            <a:ext cx="54000" cy="5400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5129280" y="549432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5130720" y="638496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6T15:06:34Z</dcterms:created>
  <dc:creator>pjie2b</dc:creator>
  <dc:description/>
  <dc:language>en-US</dc:language>
  <cp:lastModifiedBy>pjie2b</cp:lastModifiedBy>
  <dcterms:modified xsi:type="dcterms:W3CDTF">2007-09-20T14:47:42Z</dcterms:modified>
  <cp:revision>2</cp:revision>
  <dc:subject/>
  <dc:title>PowerPoint Presentation</dc:title>
</cp:coreProperties>
</file>